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6" d="100"/>
          <a:sy n="106" d="100"/>
        </p:scale>
        <p:origin x="176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5F31522-8025-415D-BBF4-3F15506213D4}" type="datetimeFigureOut">
              <a:rPr lang="it-IT" smtClean="0"/>
              <a:t>16/02/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39522288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5F31522-8025-415D-BBF4-3F15506213D4}" type="datetimeFigureOut">
              <a:rPr lang="it-IT" smtClean="0"/>
              <a:t>16/02/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19989658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5F31522-8025-415D-BBF4-3F15506213D4}" type="datetimeFigureOut">
              <a:rPr lang="it-IT" smtClean="0"/>
              <a:t>16/02/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40792088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5F31522-8025-415D-BBF4-3F15506213D4}" type="datetimeFigureOut">
              <a:rPr lang="it-IT" smtClean="0"/>
              <a:t>16/02/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16479651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5F31522-8025-415D-BBF4-3F15506213D4}" type="datetimeFigureOut">
              <a:rPr lang="it-IT" smtClean="0"/>
              <a:t>16/02/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42166854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5F31522-8025-415D-BBF4-3F15506213D4}" type="datetimeFigureOut">
              <a:rPr lang="it-IT" smtClean="0"/>
              <a:t>16/02/20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10778820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5F31522-8025-415D-BBF4-3F15506213D4}" type="datetimeFigureOut">
              <a:rPr lang="it-IT" smtClean="0"/>
              <a:t>16/02/2023</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1292413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5F31522-8025-415D-BBF4-3F15506213D4}" type="datetimeFigureOut">
              <a:rPr lang="it-IT" smtClean="0"/>
              <a:t>16/02/2023</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29229007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5F31522-8025-415D-BBF4-3F15506213D4}" type="datetimeFigureOut">
              <a:rPr lang="it-IT" smtClean="0"/>
              <a:t>16/02/2023</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31783216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5F31522-8025-415D-BBF4-3F15506213D4}" type="datetimeFigureOut">
              <a:rPr lang="it-IT" smtClean="0"/>
              <a:t>16/02/20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22966364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5F31522-8025-415D-BBF4-3F15506213D4}" type="datetimeFigureOut">
              <a:rPr lang="it-IT" smtClean="0"/>
              <a:t>16/02/20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7CA8DE68-5104-4B6E-A4A7-8510F96DBF75}" type="slidenum">
              <a:rPr lang="it-IT" smtClean="0"/>
              <a:t>‹#›</a:t>
            </a:fld>
            <a:endParaRPr lang="it-IT"/>
          </a:p>
        </p:txBody>
      </p:sp>
    </p:spTree>
    <p:extLst>
      <p:ext uri="{BB962C8B-B14F-4D97-AF65-F5344CB8AC3E}">
        <p14:creationId xmlns:p14="http://schemas.microsoft.com/office/powerpoint/2010/main" val="32690461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5F31522-8025-415D-BBF4-3F15506213D4}" type="datetimeFigureOut">
              <a:rPr lang="it-IT" smtClean="0"/>
              <a:t>16/02/2023</a:t>
            </a:fld>
            <a:endParaRPr lang="it-IT"/>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CA8DE68-5104-4B6E-A4A7-8510F96DBF75}" type="slidenum">
              <a:rPr lang="it-IT" smtClean="0"/>
              <a:t>‹#›</a:t>
            </a:fld>
            <a:endParaRPr lang="it-IT"/>
          </a:p>
        </p:txBody>
      </p:sp>
    </p:spTree>
    <p:extLst>
      <p:ext uri="{BB962C8B-B14F-4D97-AF65-F5344CB8AC3E}">
        <p14:creationId xmlns:p14="http://schemas.microsoft.com/office/powerpoint/2010/main" val="71871299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110837" y="0"/>
            <a:ext cx="8793018" cy="6858000"/>
            <a:chOff x="110837" y="0"/>
            <a:chExt cx="8793018" cy="6858000"/>
          </a:xfrm>
        </p:grpSpPr>
        <p:sp>
          <p:nvSpPr>
            <p:cNvPr id="2" name="Rectangle 1"/>
            <p:cNvSpPr/>
            <p:nvPr/>
          </p:nvSpPr>
          <p:spPr>
            <a:xfrm>
              <a:off x="110837" y="5534561"/>
              <a:ext cx="8793018" cy="1323439"/>
            </a:xfrm>
            <a:prstGeom prst="rect">
              <a:avLst/>
            </a:prstGeom>
          </p:spPr>
          <p:txBody>
            <a:bodyPr wrap="square">
              <a:spAutoFit/>
            </a:bodyPr>
            <a:lstStyle/>
            <a:p>
              <a:pPr algn="just"/>
              <a:r>
                <a:rPr lang="en-US" sz="16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upplementary </a:t>
              </a:r>
              <a:r>
                <a:rPr lang="en-US" sz="160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Figure S1</a:t>
              </a:r>
              <a:r>
                <a:rPr lang="en-US" sz="16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Principal component analysis performed on the log 10-transformed and UV scaled metabolite concentration of 24 and 48hpi samples. Each genotype has three biological replicates (small dots) for each year (2019 and 2021). The red color is for inoculated samples (I= inoculated samples) and the blue is for non-inoculated samples (NI= not inoculated samples).</a:t>
              </a:r>
              <a:endParaRPr lang="it-IT" sz="1600" dirty="0"/>
            </a:p>
          </p:txBody>
        </p:sp>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t="5652" b="5425"/>
            <a:stretch/>
          </p:blipFill>
          <p:spPr>
            <a:xfrm>
              <a:off x="1182255" y="0"/>
              <a:ext cx="7185890" cy="5534561"/>
            </a:xfrm>
            <a:prstGeom prst="rect">
              <a:avLst/>
            </a:prstGeom>
          </p:spPr>
        </p:pic>
      </p:grpSp>
    </p:spTree>
    <p:extLst>
      <p:ext uri="{BB962C8B-B14F-4D97-AF65-F5344CB8AC3E}">
        <p14:creationId xmlns:p14="http://schemas.microsoft.com/office/powerpoint/2010/main" val="371781355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TotalTime>
  <Words>68</Words>
  <Application>Microsoft Office PowerPoint</Application>
  <PresentationFormat>On-screen Show (4:3)</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Palatino Linotype</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tente Windows</dc:creator>
  <cp:lastModifiedBy>MDPI</cp:lastModifiedBy>
  <cp:revision>3</cp:revision>
  <dcterms:created xsi:type="dcterms:W3CDTF">2023-02-13T10:51:41Z</dcterms:created>
  <dcterms:modified xsi:type="dcterms:W3CDTF">2023-02-16T01:29:55Z</dcterms:modified>
</cp:coreProperties>
</file>